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24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24" autoAdjust="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298" y="86"/>
      </p:cViewPr>
      <p:guideLst>
        <p:guide orient="horz" pos="2160"/>
        <p:guide pos="32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847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117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39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2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291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206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144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25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269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584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88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87071-7722-4B1D-AA6D-528E68F4B125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42E70-704E-43C4-AD30-3E8CF8357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397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A0C5C2C-31C9-4A13-A5AB-02DE18DD438F}"/>
              </a:ext>
            </a:extLst>
          </p:cNvPr>
          <p:cNvSpPr txBox="1"/>
          <p:nvPr/>
        </p:nvSpPr>
        <p:spPr>
          <a:xfrm>
            <a:off x="589850" y="1298630"/>
            <a:ext cx="7804641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Relationship of continuous glucose monitoring-related metrics with HbA1c and residual β-cell function in Japanese patients with type 1 diabetes</a:t>
            </a:r>
          </a:p>
          <a:p>
            <a:endParaRPr lang="ja-JP" altLang="ja-JP" kern="100" dirty="0">
              <a:effectLst/>
              <a:latin typeface="Times New Roman" panose="02020603050405020304" pitchFamily="18" charset="0"/>
              <a:ea typeface="平成明朝"/>
              <a:cs typeface="Times New Roman" panose="02020603050405020304" pitchFamily="18" charset="0"/>
            </a:endParaRPr>
          </a:p>
          <a:p>
            <a:pPr>
              <a:tabLst>
                <a:tab pos="3911600" algn="l"/>
              </a:tabLst>
            </a:pP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Naru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Babaya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Shinsuke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Noso, Yoshihisa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Hiromine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Yasunori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Taketomo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</a:p>
          <a:p>
            <a:pPr>
              <a:tabLst>
                <a:tab pos="3911600" algn="l"/>
              </a:tabLst>
            </a:pP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Fumimaru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Niwano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Sawa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Yoshida, Sara </a:t>
            </a:r>
            <a:r>
              <a:rPr lang="en-US" altLang="ja-JP" kern="100" dirty="0" err="1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Yasutake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</a:t>
            </a:r>
            <a:r>
              <a:rPr lang="en-US" altLang="ja-JP" kern="100" dirty="0"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Yumiko Kawabata, </a:t>
            </a:r>
          </a:p>
          <a:p>
            <a:pPr>
              <a:tabLst>
                <a:tab pos="3911600" algn="l"/>
              </a:tabLst>
            </a:pPr>
            <a:r>
              <a:rPr lang="en-US" altLang="ja-JP" kern="100" dirty="0">
                <a:effectLst/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Hiroshi Ikegami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613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872A4D40-52AF-467C-B2F1-32192B1428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1167118"/>
              </p:ext>
            </p:extLst>
          </p:nvPr>
        </p:nvGraphicFramePr>
        <p:xfrm>
          <a:off x="5641273" y="1311713"/>
          <a:ext cx="3419475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420000" imgH="2880000" progId="Prism5.Document">
                  <p:embed/>
                </p:oleObj>
              </mc:Choice>
              <mc:Fallback>
                <p:oleObj name="Prism Project" r:id="rId2" imgW="3420000" imgH="2880000" progId="Prism5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872A4D40-52AF-467C-B2F1-32192B1428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41273" y="1311713"/>
                        <a:ext cx="3419475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29977CEF-124D-4A68-925B-C85D44C061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6714793"/>
              </p:ext>
            </p:extLst>
          </p:nvPr>
        </p:nvGraphicFramePr>
        <p:xfrm>
          <a:off x="3085755" y="1296719"/>
          <a:ext cx="3168650" cy="295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168000" imgH="2952000" progId="Prism5.Document">
                  <p:embed/>
                </p:oleObj>
              </mc:Choice>
              <mc:Fallback>
                <p:oleObj name="Prism Project" r:id="rId4" imgW="3168000" imgH="2952000" progId="Prism5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29977CEF-124D-4A68-925B-C85D44C061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85755" y="1296719"/>
                        <a:ext cx="3168650" cy="295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D5AA71B3-FD3F-4CD8-BC1B-55DC5D5541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9372547"/>
              </p:ext>
            </p:extLst>
          </p:nvPr>
        </p:nvGraphicFramePr>
        <p:xfrm>
          <a:off x="138851" y="1263544"/>
          <a:ext cx="3168650" cy="295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3168000" imgH="2952000" progId="Prism5.Document">
                  <p:embed/>
                </p:oleObj>
              </mc:Choice>
              <mc:Fallback>
                <p:oleObj name="Prism Project" r:id="rId6" imgW="3168000" imgH="2952000" progId="Prism5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D5AA71B3-FD3F-4CD8-BC1B-55DC5D5541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8851" y="1263544"/>
                        <a:ext cx="3168650" cy="295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AD12349-D069-44F8-80D9-BEFDBA697790}"/>
              </a:ext>
            </a:extLst>
          </p:cNvPr>
          <p:cNvSpPr txBox="1"/>
          <p:nvPr/>
        </p:nvSpPr>
        <p:spPr>
          <a:xfrm>
            <a:off x="275057" y="356806"/>
            <a:ext cx="2600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</a:t>
            </a:r>
            <a:r>
              <a: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613D156-2C4B-45F8-9A3D-1AC12F6B4F11}"/>
              </a:ext>
            </a:extLst>
          </p:cNvPr>
          <p:cNvSpPr txBox="1"/>
          <p:nvPr/>
        </p:nvSpPr>
        <p:spPr>
          <a:xfrm>
            <a:off x="285601" y="932702"/>
            <a:ext cx="3706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AB9C75C-145B-4897-9E17-6445AB650192}"/>
              </a:ext>
            </a:extLst>
          </p:cNvPr>
          <p:cNvSpPr txBox="1"/>
          <p:nvPr/>
        </p:nvSpPr>
        <p:spPr>
          <a:xfrm>
            <a:off x="3247151" y="932702"/>
            <a:ext cx="2785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43D12C5-C92F-4194-9D8F-DCA6C9570B92}"/>
              </a:ext>
            </a:extLst>
          </p:cNvPr>
          <p:cNvSpPr txBox="1"/>
          <p:nvPr/>
        </p:nvSpPr>
        <p:spPr>
          <a:xfrm>
            <a:off x="905218" y="2642289"/>
            <a:ext cx="14141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= -0.05412x + 11.06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C7A3FB6-7CF5-4C05-9E15-056526538073}"/>
              </a:ext>
            </a:extLst>
          </p:cNvPr>
          <p:cNvSpPr txBox="1"/>
          <p:nvPr/>
        </p:nvSpPr>
        <p:spPr>
          <a:xfrm>
            <a:off x="905218" y="2859358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1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8881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DEDA387-9621-436B-A035-E994C442662E}"/>
              </a:ext>
            </a:extLst>
          </p:cNvPr>
          <p:cNvSpPr txBox="1"/>
          <p:nvPr/>
        </p:nvSpPr>
        <p:spPr>
          <a:xfrm>
            <a:off x="4354319" y="2642289"/>
            <a:ext cx="13676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= 0.05211x + 5.969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6FA9178-424D-4248-AF5B-0BBDFB510755}"/>
              </a:ext>
            </a:extLst>
          </p:cNvPr>
          <p:cNvSpPr txBox="1"/>
          <p:nvPr/>
        </p:nvSpPr>
        <p:spPr>
          <a:xfrm>
            <a:off x="4354319" y="2859358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1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9445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4307F7D-6725-4AA3-BD0E-2E4B70A8E38B}"/>
              </a:ext>
            </a:extLst>
          </p:cNvPr>
          <p:cNvSpPr txBox="1"/>
          <p:nvPr/>
        </p:nvSpPr>
        <p:spPr>
          <a:xfrm>
            <a:off x="6069098" y="932702"/>
            <a:ext cx="3706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8E72E3D-6B20-49A3-89AA-2B0A6EE0478F}"/>
              </a:ext>
            </a:extLst>
          </p:cNvPr>
          <p:cNvSpPr txBox="1"/>
          <p:nvPr/>
        </p:nvSpPr>
        <p:spPr>
          <a:xfrm>
            <a:off x="7258969" y="2686830"/>
            <a:ext cx="13676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= 0.02556x + 3.497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F55C362-021D-4AE8-A15C-6D1038296E2C}"/>
              </a:ext>
            </a:extLst>
          </p:cNvPr>
          <p:cNvSpPr txBox="1"/>
          <p:nvPr/>
        </p:nvSpPr>
        <p:spPr>
          <a:xfrm>
            <a:off x="7258969" y="2903899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1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9732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2497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0</TotalTime>
  <Words>76</Words>
  <Application>Microsoft Office PowerPoint</Application>
  <PresentationFormat>画面に合わせる (4:3)</PresentationFormat>
  <Paragraphs>15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rism Project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RU BABAYA</dc:creator>
  <cp:lastModifiedBy>NARU BABAYA</cp:lastModifiedBy>
  <cp:revision>37</cp:revision>
  <cp:lastPrinted>2021-01-06T04:44:16Z</cp:lastPrinted>
  <dcterms:created xsi:type="dcterms:W3CDTF">2020-01-27T12:57:39Z</dcterms:created>
  <dcterms:modified xsi:type="dcterms:W3CDTF">2021-01-25T12:41:35Z</dcterms:modified>
</cp:coreProperties>
</file>